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6858000" cy="10287000" type="35mm"/>
  <p:notesSz cx="10691813" cy="7559675"/>
  <p:defaultTextStyle>
    <a:defPPr>
      <a:defRPr lang="en-US"/>
    </a:defPPr>
    <a:lvl1pPr marL="0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1pPr>
    <a:lvl2pPr marL="284836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2pPr>
    <a:lvl3pPr marL="569671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3pPr>
    <a:lvl4pPr marL="854507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4pPr>
    <a:lvl5pPr marL="1139342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5pPr>
    <a:lvl6pPr marL="1424178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6pPr>
    <a:lvl7pPr marL="1709014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7pPr>
    <a:lvl8pPr marL="1993849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8pPr>
    <a:lvl9pPr marL="2278685" algn="l" defTabSz="569671" rtl="0" eaLnBrk="1" latinLnBrk="0" hangingPunct="1">
      <a:defRPr sz="112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A690FA-4521-483B-8979-7EC8239FAC7E}" v="12" dt="2024-12-15T16:48:48.95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49923" autoAdjust="0"/>
  </p:normalViewPr>
  <p:slideViewPr>
    <p:cSldViewPr snapToGrid="0">
      <p:cViewPr>
        <p:scale>
          <a:sx n="54" d="100"/>
          <a:sy n="54" d="100"/>
        </p:scale>
        <p:origin x="2312" y="8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teo Bauckneht" userId="4a914d2583043e62" providerId="LiveId" clId="{91A690FA-4521-483B-8979-7EC8239FAC7E}"/>
    <pc:docChg chg="undo redo custSel modSld modMainMaster modNotesMaster">
      <pc:chgData name="Matteo Bauckneht" userId="4a914d2583043e62" providerId="LiveId" clId="{91A690FA-4521-483B-8979-7EC8239FAC7E}" dt="2024-12-15T17:55:33.502" v="492" actId="20577"/>
      <pc:docMkLst>
        <pc:docMk/>
      </pc:docMkLst>
      <pc:sldChg chg="addSp delSp modSp mod modNotes">
        <pc:chgData name="Matteo Bauckneht" userId="4a914d2583043e62" providerId="LiveId" clId="{91A690FA-4521-483B-8979-7EC8239FAC7E}" dt="2024-12-15T17:55:33.502" v="492" actId="20577"/>
        <pc:sldMkLst>
          <pc:docMk/>
          <pc:sldMk cId="0" sldId="256"/>
        </pc:sldMkLst>
        <pc:spChg chg="add del mod">
          <ac:chgData name="Matteo Bauckneht" userId="4a914d2583043e62" providerId="LiveId" clId="{91A690FA-4521-483B-8979-7EC8239FAC7E}" dt="2024-12-15T16:49:13.761" v="407" actId="478"/>
          <ac:spMkLst>
            <pc:docMk/>
            <pc:sldMk cId="0" sldId="256"/>
            <ac:spMk id="2" creationId="{55DDAEA3-8098-1A46-26AB-985305BFD3B3}"/>
          </ac:spMkLst>
        </pc:spChg>
        <pc:spChg chg="add del mod">
          <ac:chgData name="Matteo Bauckneht" userId="4a914d2583043e62" providerId="LiveId" clId="{91A690FA-4521-483B-8979-7EC8239FAC7E}" dt="2024-12-15T16:49:13.761" v="407" actId="478"/>
          <ac:spMkLst>
            <pc:docMk/>
            <pc:sldMk cId="0" sldId="256"/>
            <ac:spMk id="3" creationId="{D53A9917-231A-815D-B07E-508A48AF2777}"/>
          </ac:spMkLst>
        </pc:spChg>
        <pc:spChg chg="mod">
          <ac:chgData name="Matteo Bauckneht" userId="4a914d2583043e62" providerId="LiveId" clId="{91A690FA-4521-483B-8979-7EC8239FAC7E}" dt="2024-12-15T17:55:33.502" v="492" actId="20577"/>
          <ac:spMkLst>
            <pc:docMk/>
            <pc:sldMk cId="0" sldId="256"/>
            <ac:spMk id="38" creationId="{00000000-0000-0000-0000-000000000000}"/>
          </ac:spMkLst>
        </pc:spChg>
        <pc:spChg chg="del mod">
          <ac:chgData name="Matteo Bauckneht" userId="4a914d2583043e62" providerId="LiveId" clId="{91A690FA-4521-483B-8979-7EC8239FAC7E}" dt="2024-12-15T16:21:15.071" v="61" actId="478"/>
          <ac:spMkLst>
            <pc:docMk/>
            <pc:sldMk cId="0" sldId="256"/>
            <ac:spMk id="39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0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1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2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2.861" v="1" actId="478"/>
          <ac:spMkLst>
            <pc:docMk/>
            <pc:sldMk cId="0" sldId="256"/>
            <ac:spMk id="43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2.861" v="1" actId="478"/>
          <ac:spMkLst>
            <pc:docMk/>
            <pc:sldMk cId="0" sldId="256"/>
            <ac:spMk id="44" creationId="{00000000-0000-0000-0000-000000000000}"/>
          </ac:spMkLst>
        </pc:spChg>
        <pc:spChg chg="mod">
          <ac:chgData name="Matteo Bauckneht" userId="4a914d2583043e62" providerId="LiveId" clId="{91A690FA-4521-483B-8979-7EC8239FAC7E}" dt="2024-12-15T17:54:56.852" v="489" actId="255"/>
          <ac:spMkLst>
            <pc:docMk/>
            <pc:sldMk cId="0" sldId="256"/>
            <ac:spMk id="45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6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7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48" creationId="{00000000-0000-0000-0000-000000000000}"/>
          </ac:spMkLst>
        </pc:spChg>
        <pc:spChg chg="mod">
          <ac:chgData name="Matteo Bauckneht" userId="4a914d2583043e62" providerId="LiveId" clId="{91A690FA-4521-483B-8979-7EC8239FAC7E}" dt="2024-12-15T17:54:56.852" v="489" actId="255"/>
          <ac:spMkLst>
            <pc:docMk/>
            <pc:sldMk cId="0" sldId="256"/>
            <ac:spMk id="49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0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1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2" creationId="{00000000-0000-0000-0000-000000000000}"/>
          </ac:spMkLst>
        </pc:spChg>
        <pc:spChg chg="del mod">
          <ac:chgData name="Matteo Bauckneht" userId="4a914d2583043e62" providerId="LiveId" clId="{91A690FA-4521-483B-8979-7EC8239FAC7E}" dt="2024-12-15T16:41:37.806" v="351" actId="21"/>
          <ac:spMkLst>
            <pc:docMk/>
            <pc:sldMk cId="0" sldId="256"/>
            <ac:spMk id="53" creationId="{00000000-0000-0000-0000-000000000000}"/>
          </ac:spMkLst>
        </pc:spChg>
        <pc:spChg chg="del mod">
          <ac:chgData name="Matteo Bauckneht" userId="4a914d2583043e62" providerId="LiveId" clId="{91A690FA-4521-483B-8979-7EC8239FAC7E}" dt="2024-12-15T16:31:12.928" v="168" actId="478"/>
          <ac:spMkLst>
            <pc:docMk/>
            <pc:sldMk cId="0" sldId="256"/>
            <ac:spMk id="54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5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6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7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8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59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0" creationId="{00000000-0000-0000-0000-000000000000}"/>
          </ac:spMkLst>
        </pc:spChg>
        <pc:spChg chg="mod">
          <ac:chgData name="Matteo Bauckneht" userId="4a914d2583043e62" providerId="LiveId" clId="{91A690FA-4521-483B-8979-7EC8239FAC7E}" dt="2024-12-15T17:55:03.485" v="490" actId="1076"/>
          <ac:spMkLst>
            <pc:docMk/>
            <pc:sldMk cId="0" sldId="256"/>
            <ac:spMk id="61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2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3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4" creationId="{00000000-0000-0000-0000-000000000000}"/>
          </ac:spMkLst>
        </pc:spChg>
        <pc:spChg chg="del mod">
          <ac:chgData name="Matteo Bauckneht" userId="4a914d2583043e62" providerId="LiveId" clId="{91A690FA-4521-483B-8979-7EC8239FAC7E}" dt="2024-12-15T16:31:15.031" v="169" actId="478"/>
          <ac:spMkLst>
            <pc:docMk/>
            <pc:sldMk cId="0" sldId="256"/>
            <ac:spMk id="65" creationId="{00000000-0000-0000-0000-000000000000}"/>
          </ac:spMkLst>
        </pc:spChg>
        <pc:spChg chg="del mod">
          <ac:chgData name="Matteo Bauckneht" userId="4a914d2583043e62" providerId="LiveId" clId="{91A690FA-4521-483B-8979-7EC8239FAC7E}" dt="2024-12-15T16:41:37.806" v="351" actId="21"/>
          <ac:spMkLst>
            <pc:docMk/>
            <pc:sldMk cId="0" sldId="256"/>
            <ac:spMk id="66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7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8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69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0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1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2" creationId="{00000000-0000-0000-0000-000000000000}"/>
          </ac:spMkLst>
        </pc:spChg>
        <pc:spChg chg="mod">
          <ac:chgData name="Matteo Bauckneht" userId="4a914d2583043e62" providerId="LiveId" clId="{91A690FA-4521-483B-8979-7EC8239FAC7E}" dt="2024-12-15T17:55:14.329" v="491" actId="1076"/>
          <ac:spMkLst>
            <pc:docMk/>
            <pc:sldMk cId="0" sldId="256"/>
            <ac:spMk id="73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4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5" creationId="{00000000-0000-0000-0000-000000000000}"/>
          </ac:spMkLst>
        </pc:spChg>
        <pc:spChg chg="del">
          <ac:chgData name="Matteo Bauckneht" userId="4a914d2583043e62" providerId="LiveId" clId="{91A690FA-4521-483B-8979-7EC8239FAC7E}" dt="2024-12-15T16:20:10.139" v="0" actId="478"/>
          <ac:spMkLst>
            <pc:docMk/>
            <pc:sldMk cId="0" sldId="256"/>
            <ac:spMk id="76" creationId="{00000000-0000-0000-0000-000000000000}"/>
          </ac:spMkLst>
        </pc:spChg>
        <pc:picChg chg="add del mod">
          <ac:chgData name="Matteo Bauckneht" userId="4a914d2583043e62" providerId="LiveId" clId="{91A690FA-4521-483B-8979-7EC8239FAC7E}" dt="2024-12-15T16:49:13.761" v="407" actId="478"/>
          <ac:picMkLst>
            <pc:docMk/>
            <pc:sldMk cId="0" sldId="256"/>
            <ac:picMk id="4" creationId="{B289280C-B9D7-758D-79FC-91EEC64F2364}"/>
          </ac:picMkLst>
        </pc:picChg>
        <pc:picChg chg="add mod">
          <ac:chgData name="Matteo Bauckneht" userId="4a914d2583043e62" providerId="LiveId" clId="{91A690FA-4521-483B-8979-7EC8239FAC7E}" dt="2024-12-15T17:26:09.354" v="487" actId="1036"/>
          <ac:picMkLst>
            <pc:docMk/>
            <pc:sldMk cId="0" sldId="256"/>
            <ac:picMk id="5" creationId="{58FD427F-842D-4AF7-00F7-4C0F02CDE54E}"/>
          </ac:picMkLst>
        </pc:picChg>
        <pc:picChg chg="add mod">
          <ac:chgData name="Matteo Bauckneht" userId="4a914d2583043e62" providerId="LiveId" clId="{91A690FA-4521-483B-8979-7EC8239FAC7E}" dt="2024-12-15T17:26:09.354" v="487" actId="1036"/>
          <ac:picMkLst>
            <pc:docMk/>
            <pc:sldMk cId="0" sldId="256"/>
            <ac:picMk id="6" creationId="{586C3BA3-926C-8BAC-BDBD-1468D633DC24}"/>
          </ac:picMkLst>
        </pc:picChg>
      </pc:sldChg>
      <pc:sldMasterChg chg="modSp modSldLayout">
        <pc:chgData name="Matteo Bauckneht" userId="4a914d2583043e62" providerId="LiveId" clId="{91A690FA-4521-483B-8979-7EC8239FAC7E}" dt="2024-12-15T16:34:18.495" v="313"/>
        <pc:sldMasterMkLst>
          <pc:docMk/>
          <pc:sldMasterMk cId="0" sldId="2147483648"/>
        </pc:sldMasterMkLst>
        <pc:spChg chg="mod">
          <ac:chgData name="Matteo Bauckneht" userId="4a914d2583043e62" providerId="LiveId" clId="{91A690FA-4521-483B-8979-7EC8239FAC7E}" dt="2024-12-15T16:34:18.495" v="313"/>
          <ac:spMkLst>
            <pc:docMk/>
            <pc:sldMasterMk cId="0" sldId="2147483648"/>
            <ac:spMk id="2" creationId="{00000000-0000-0000-0000-000000000000}"/>
          </ac:spMkLst>
        </pc:spChg>
        <pc:spChg chg="mod">
          <ac:chgData name="Matteo Bauckneht" userId="4a914d2583043e62" providerId="LiveId" clId="{91A690FA-4521-483B-8979-7EC8239FAC7E}" dt="2024-12-15T16:34:18.495" v="313"/>
          <ac:spMkLst>
            <pc:docMk/>
            <pc:sldMasterMk cId="0" sldId="2147483648"/>
            <ac:spMk id="3" creationId="{00000000-0000-0000-0000-000000000000}"/>
          </ac:spMkLst>
        </pc:sp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0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0"/>
              <ac:spMk id="2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0"/>
              <ac:spMk id="3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1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1"/>
              <ac:spMk id="4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1"/>
              <ac:spMk id="5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2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2"/>
              <ac:spMk id="6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2"/>
              <ac:spMk id="7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2"/>
              <ac:spMk id="8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3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3"/>
              <ac:spMk id="9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4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4"/>
              <ac:spMk id="10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5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5"/>
              <ac:spMk id="11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5"/>
              <ac:spMk id="12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5"/>
              <ac:spMk id="13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5"/>
              <ac:spMk id="14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6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6"/>
              <ac:spMk id="15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6"/>
              <ac:spMk id="16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6"/>
              <ac:spMk id="17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6"/>
              <ac:spMk id="18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7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7"/>
              <ac:spMk id="19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7"/>
              <ac:spMk id="20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7"/>
              <ac:spMk id="21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7"/>
              <ac:spMk id="22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8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8"/>
              <ac:spMk id="23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8"/>
              <ac:spMk id="24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8"/>
              <ac:spMk id="25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59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9"/>
              <ac:spMk id="26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9"/>
              <ac:spMk id="27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9"/>
              <ac:spMk id="28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9"/>
              <ac:spMk id="29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59"/>
              <ac:spMk id="30" creationId="{00000000-0000-0000-0000-000000000000}"/>
            </ac:spMkLst>
          </pc:spChg>
        </pc:sldLayoutChg>
        <pc:sldLayoutChg chg="modSp">
          <pc:chgData name="Matteo Bauckneht" userId="4a914d2583043e62" providerId="LiveId" clId="{91A690FA-4521-483B-8979-7EC8239FAC7E}" dt="2024-12-15T16:34:18.495" v="313"/>
          <pc:sldLayoutMkLst>
            <pc:docMk/>
            <pc:sldMasterMk cId="0" sldId="2147483648"/>
            <pc:sldLayoutMk cId="0" sldId="2147483660"/>
          </pc:sldLayoutMkLst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1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2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3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4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5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6" creationId="{00000000-0000-0000-0000-000000000000}"/>
            </ac:spMkLst>
          </pc:spChg>
          <pc:spChg chg="mod">
            <ac:chgData name="Matteo Bauckneht" userId="4a914d2583043e62" providerId="LiveId" clId="{91A690FA-4521-483B-8979-7EC8239FAC7E}" dt="2024-12-15T16:34:18.495" v="313"/>
            <ac:spMkLst>
              <pc:docMk/>
              <pc:sldMasterMk cId="0" sldId="2147483648"/>
              <pc:sldLayoutMk cId="0" sldId="2147483660"/>
              <ac:spMk id="37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634167" cy="37938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6055402" y="0"/>
            <a:ext cx="4634167" cy="37938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269BF-84D5-47DB-BF48-D5E0CF034B1C}" type="datetimeFigureOut">
              <a:rPr lang="en-GB" smtClean="0"/>
              <a:t>15/1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495800" y="944563"/>
            <a:ext cx="1700213" cy="25511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68733" y="3637848"/>
            <a:ext cx="8554348" cy="297672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7180288"/>
            <a:ext cx="4634167" cy="3793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6055402" y="7180288"/>
            <a:ext cx="4634167" cy="3793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586BB0-4B51-4E23-AD38-671727C0A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0916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1pPr>
    <a:lvl2pPr marL="284836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2pPr>
    <a:lvl3pPr marL="569671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3pPr>
    <a:lvl4pPr marL="854507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4pPr>
    <a:lvl5pPr marL="1139342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5pPr>
    <a:lvl6pPr marL="1424178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6pPr>
    <a:lvl7pPr marL="1709014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7pPr>
    <a:lvl8pPr marL="1993849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8pPr>
    <a:lvl9pPr marL="2278685" algn="l" defTabSz="569671" rtl="0" eaLnBrk="1" latinLnBrk="0" hangingPunct="1">
      <a:defRPr sz="74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495800" y="944563"/>
            <a:ext cx="1700213" cy="255111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586BB0-4B51-4E23-AD38-671727C0A5D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1256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832" y="2406780"/>
            <a:ext cx="6171999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832" y="5523120"/>
            <a:ext cx="6171999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480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835" y="552312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480" y="552312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800" y="240678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765" y="240678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835" y="552312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800" y="552312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765" y="5523120"/>
            <a:ext cx="1987335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832" y="2406780"/>
            <a:ext cx="6171999" cy="59659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832" y="2406780"/>
            <a:ext cx="6171999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3011783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480" y="2406780"/>
            <a:ext cx="3011783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857185" y="1683720"/>
            <a:ext cx="5143095" cy="16597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480" y="2406780"/>
            <a:ext cx="3011783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835" y="552312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3011783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480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480" y="552312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575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835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480" y="2406780"/>
            <a:ext cx="3011783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832" y="5523120"/>
            <a:ext cx="6171999" cy="28452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26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857185" y="1683720"/>
            <a:ext cx="5143095" cy="35802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463" b="0" strike="noStrike" spc="-1">
                <a:latin typeface="Arial"/>
              </a:rPr>
              <a:t>Fai clic per modificare il formato del testo del titolo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832" y="2406780"/>
            <a:ext cx="6171999" cy="5965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600" b="0" strike="noStrike" spc="-1">
                <a:latin typeface="Arial"/>
              </a:rPr>
              <a:t>Fai clic per modificare il formato del testo della struttura</a:t>
            </a:r>
          </a:p>
          <a:p>
            <a:pPr marL="702000" lvl="1" indent="-263250">
              <a:spcBef>
                <a:spcPts val="921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2275" b="0" strike="noStrike" spc="-1">
                <a:latin typeface="Arial"/>
              </a:rPr>
              <a:t>Secondo livello struttura</a:t>
            </a:r>
          </a:p>
          <a:p>
            <a:pPr marL="1053000" lvl="2" indent="-234000">
              <a:spcBef>
                <a:spcPts val="691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950" b="0" strike="noStrike" spc="-1">
                <a:latin typeface="Arial"/>
              </a:rPr>
              <a:t>Terzo livello struttura</a:t>
            </a:r>
          </a:p>
          <a:p>
            <a:pPr marL="1404000" lvl="3" indent="-175500">
              <a:spcBef>
                <a:spcPts val="461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625" b="0" strike="noStrike" spc="-1">
                <a:latin typeface="Arial"/>
              </a:rPr>
              <a:t>Quarto livello struttura</a:t>
            </a:r>
          </a:p>
          <a:p>
            <a:pPr marL="1755000" lvl="4" indent="-175500">
              <a:spcBef>
                <a:spcPts val="2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625" b="0" strike="noStrike" spc="-1">
                <a:latin typeface="Arial"/>
              </a:rPr>
              <a:t>Quinto livello struttura</a:t>
            </a:r>
          </a:p>
          <a:p>
            <a:pPr marL="2106000" lvl="5" indent="-175500">
              <a:spcBef>
                <a:spcPts val="2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625" b="0" strike="noStrike" spc="-1">
                <a:latin typeface="Arial"/>
              </a:rPr>
              <a:t>Sesto livello struttura</a:t>
            </a:r>
          </a:p>
          <a:p>
            <a:pPr marL="2457000" lvl="6" indent="-175500">
              <a:spcBef>
                <a:spcPts val="23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625" b="0" strike="noStrike" spc="-1">
                <a:latin typeface="Arial"/>
              </a:rPr>
              <a:t>Settimo livello struttura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742950" rtl="0" eaLnBrk="1" latinLnBrk="0" hangingPunct="1">
        <a:lnSpc>
          <a:spcPct val="90000"/>
        </a:lnSpc>
        <a:spcBef>
          <a:spcPct val="0"/>
        </a:spcBef>
        <a:buNone/>
        <a:defRPr sz="3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00" indent="-324000" algn="l" defTabSz="742950" rtl="0" eaLnBrk="1" latinLnBrk="0" hangingPunct="1">
        <a:lnSpc>
          <a:spcPct val="90000"/>
        </a:lnSpc>
        <a:spcBef>
          <a:spcPts val="1417"/>
        </a:spcBef>
        <a:buClr>
          <a:srgbClr val="000000"/>
        </a:buClr>
        <a:buSzPct val="45000"/>
        <a:buFont typeface="Wingdings" charset="2"/>
        <a:buChar char=""/>
        <a:defRPr sz="2275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286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3pPr>
      <a:lvl4pPr marL="13001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6716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20431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4145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7860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31575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3pPr>
      <a:lvl4pPr marL="11144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4859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18573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6003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29718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ttangolo 5"/>
          <p:cNvSpPr/>
          <p:nvPr/>
        </p:nvSpPr>
        <p:spPr>
          <a:xfrm>
            <a:off x="415131" y="372984"/>
            <a:ext cx="6027737" cy="1976996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73125" tIns="36563" rIns="73125" bIns="36563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Consecutive [</a:t>
            </a:r>
            <a:r>
              <a:rPr lang="en-GB" sz="1800" spc="-1" baseline="30000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18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F]PSMA-1007 PET/CT scans conducted at IRCCS Ospedale </a:t>
            </a:r>
            <a:r>
              <a:rPr lang="en-GB" sz="1800" spc="-1" dirty="0" err="1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Policlinico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 San Martino between August 2021 and March 2023 (n=308) 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Rettangolo 12"/>
          <p:cNvSpPr/>
          <p:nvPr/>
        </p:nvSpPr>
        <p:spPr>
          <a:xfrm>
            <a:off x="415130" y="4751705"/>
            <a:ext cx="6027737" cy="1173644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73125" tIns="36563" rIns="73125" bIns="36563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 ≥1 focal bone uptake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163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Rettangolo 16"/>
          <p:cNvSpPr/>
          <p:nvPr/>
        </p:nvSpPr>
        <p:spPr>
          <a:xfrm>
            <a:off x="415130" y="9462237"/>
            <a:ext cx="6027738" cy="450450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73125" tIns="36563" rIns="73125" bIns="36563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Included patients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102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Rettangolo 73"/>
          <p:cNvSpPr/>
          <p:nvPr/>
        </p:nvSpPr>
        <p:spPr>
          <a:xfrm>
            <a:off x="2254107" y="6337523"/>
            <a:ext cx="4188761" cy="2712539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73125" tIns="36563" rIns="73125" bIns="36563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Excluded patients: 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- other malignancies, bone disorders or inflammatory processes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2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- CRPC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17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- Uncertainty in the standard of reference at follow-up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42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Rettangolo 32"/>
          <p:cNvSpPr/>
          <p:nvPr/>
        </p:nvSpPr>
        <p:spPr>
          <a:xfrm>
            <a:off x="2254107" y="3241472"/>
            <a:ext cx="4188761" cy="618740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73125" tIns="36563" rIns="73125" bIns="36563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o bone uptake (</a:t>
            </a:r>
            <a:r>
              <a:rPr lang="en-GB" sz="1800" i="1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 </a:t>
            </a:r>
            <a:r>
              <a:rPr lang="en-GB" sz="1800" spc="-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= 145)</a:t>
            </a:r>
            <a:endParaRPr lang="en-GB" sz="1800" spc="-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FD427F-842D-4AF7-00F7-4C0F02CDE5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7195" y="2515778"/>
            <a:ext cx="724061" cy="222668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86C3BA3-926C-8BAC-BDBD-1468D633DC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7195" y="6145347"/>
            <a:ext cx="724061" cy="331689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2</TotalTime>
  <Words>92</Words>
  <Application>Microsoft Office PowerPoint</Application>
  <PresentationFormat>35 mm Slides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Symbol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subject/>
  <dc:creator>Matteo Bauckneht</dc:creator>
  <dc:description/>
  <cp:lastModifiedBy>Matteo Bauckneht</cp:lastModifiedBy>
  <cp:revision>8</cp:revision>
  <dcterms:created xsi:type="dcterms:W3CDTF">2024-01-02T16:27:43Z</dcterms:created>
  <dcterms:modified xsi:type="dcterms:W3CDTF">2024-12-15T17:55:36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Widescreen</vt:lpwstr>
  </property>
  <property fmtid="{D5CDD505-2E9C-101B-9397-08002B2CF9AE}" pid="3" name="Slides">
    <vt:i4>1</vt:i4>
  </property>
</Properties>
</file>